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21754" r="1243" b="51488"/>
          <a:stretch/>
        </p:blipFill>
        <p:spPr bwMode="auto">
          <a:xfrm>
            <a:off x="1219200" y="533400"/>
            <a:ext cx="6477000" cy="25908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143000" y="3429000"/>
            <a:ext cx="65532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terologous and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osubtypic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-stimul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uced mainly mono-functional T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imals were vaccinated 3 times and challenged with X-31 virus. Three days post challenge, animals were sacrificed and lymphocytes were extracted from spleens. Cells were stained for surface markers (CD3, CD4, CD8) and intracellular cytokine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NFα and IL2) afte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terologous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osubtyp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-stimulation, and analyzed by flow cytometry. Data represents percentages of (H1N1)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X-31 (B) specific CD4 T cells expressing one or more cytokines. Groups: 1: PBS, 2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3: WIV+CAF0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4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5: WIV+ CAF09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6: WIV+ CTA1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7: WIV+ CTA1-3Me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8889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.C. Bhide</dc:creator>
  <cp:lastModifiedBy>Y.C. Bhide</cp:lastModifiedBy>
  <cp:revision>1</cp:revision>
  <dcterms:created xsi:type="dcterms:W3CDTF">2006-08-16T00:00:00Z</dcterms:created>
  <dcterms:modified xsi:type="dcterms:W3CDTF">2018-09-27T12:05:00Z</dcterms:modified>
</cp:coreProperties>
</file>